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6" r:id="rId3"/>
    <p:sldId id="261" r:id="rId4"/>
    <p:sldId id="262" r:id="rId5"/>
    <p:sldId id="263" r:id="rId6"/>
    <p:sldId id="264" r:id="rId7"/>
    <p:sldId id="257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9" d="100"/>
          <a:sy n="49" d="100"/>
        </p:scale>
        <p:origin x="165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0752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05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818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5875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4567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978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2901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1347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0011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6707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506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1222C-6742-4282-92CF-65EE764F0599}" type="datetimeFigureOut">
              <a:rPr lang="en-GB" smtClean="0"/>
              <a:t>08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1C36C-E54F-49F8-A571-CEA6F95C56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0452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/>
          <p:nvPr/>
        </p:nvPicPr>
        <p:blipFill rotWithShape="1">
          <a:blip r:embed="rId2"/>
          <a:srcRect r="10438" b="63348"/>
          <a:stretch/>
        </p:blipFill>
        <p:spPr>
          <a:xfrm>
            <a:off x="903855" y="1355525"/>
            <a:ext cx="4839219" cy="3248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858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06932"/>
            <a:ext cx="6858000" cy="48462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80659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/>
          <p:nvPr/>
        </p:nvPicPr>
        <p:blipFill rotWithShape="1">
          <a:blip r:embed="rId2"/>
          <a:srcRect r="22964" b="3801"/>
          <a:stretch/>
        </p:blipFill>
        <p:spPr>
          <a:xfrm>
            <a:off x="1857309" y="1120126"/>
            <a:ext cx="3316270" cy="67605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20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/>
          <p:nvPr/>
        </p:nvPicPr>
        <p:blipFill rotWithShape="1">
          <a:blip r:embed="rId2"/>
          <a:srcRect b="4494"/>
          <a:stretch/>
        </p:blipFill>
        <p:spPr>
          <a:xfrm>
            <a:off x="851217" y="644152"/>
            <a:ext cx="5208389" cy="85517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540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/>
          <p:nvPr/>
        </p:nvPicPr>
        <p:blipFill rotWithShape="1">
          <a:blip r:embed="rId2"/>
          <a:srcRect b="10471"/>
          <a:stretch/>
        </p:blipFill>
        <p:spPr>
          <a:xfrm>
            <a:off x="0" y="1706434"/>
            <a:ext cx="6858000" cy="5786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6621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/>
          <p:nvPr/>
        </p:nvPicPr>
        <p:blipFill rotWithShape="1">
          <a:blip r:embed="rId2"/>
          <a:srcRect r="24827" b="45249"/>
          <a:stretch/>
        </p:blipFill>
        <p:spPr>
          <a:xfrm>
            <a:off x="1688967" y="1499903"/>
            <a:ext cx="3604928" cy="4852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2058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2BA630E-21BB-0E49-933F-88BB7D125C1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21" y="1152609"/>
            <a:ext cx="6837379" cy="40712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6836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</Words>
  <Application>Microsoft Office PowerPoint</Application>
  <PresentationFormat>A4-Papier (210 x 297 mm)</PresentationFormat>
  <Paragraphs>7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fen Fricke</dc:creator>
  <cp:lastModifiedBy>Jochen Meier</cp:lastModifiedBy>
  <cp:revision>14</cp:revision>
  <dcterms:created xsi:type="dcterms:W3CDTF">2023-03-20T12:20:17Z</dcterms:created>
  <dcterms:modified xsi:type="dcterms:W3CDTF">2023-05-08T11:37:26Z</dcterms:modified>
</cp:coreProperties>
</file>